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56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1400" y="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6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6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6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6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6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6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6/2022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6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6/2022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6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6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2/06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://creativecommons.org/licenses/by/4.0/" TargetMode="External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1080" y="5838416"/>
            <a:ext cx="79928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Schiborn</a:t>
            </a:r>
            <a:r>
              <a:rPr lang="en-GB" dirty="0"/>
              <a:t> and Schulze (2022) Diabetologia DOI 10.1007/s00125-022-05731-4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Precision prognostic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794E984-3F81-37CA-8EC1-4B8862B7D52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4152" y="1231757"/>
            <a:ext cx="8861007" cy="35704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51520" y="272842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Illustrative example of the distribution of absolute 10 year CVD risk estimated by the Pooled Cohort Equation 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BB366317-EFD2-8602-934D-C0415E9C83CF}"/>
              </a:ext>
            </a:extLst>
          </p:cNvPr>
          <p:cNvSpPr txBox="1"/>
          <p:nvPr/>
        </p:nvSpPr>
        <p:spPr>
          <a:xfrm>
            <a:off x="80984" y="5870903"/>
            <a:ext cx="79928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chiborn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and Schulze (2022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2-05731-4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2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3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A2C12E04-BC39-4A18-B847-E6E7FE663DE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76732" y="1214245"/>
            <a:ext cx="6190536" cy="4274418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95536" y="332656"/>
            <a:ext cx="82089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Novel biomarkers for prediction of nephropathy in diabetes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3A435F6-AFF0-81CD-BA7F-7FD4E15523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44592" y="908720"/>
            <a:ext cx="7080794" cy="4820329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B79CA070-83CA-750C-9905-46D69DB14D7E}"/>
              </a:ext>
            </a:extLst>
          </p:cNvPr>
          <p:cNvSpPr txBox="1"/>
          <p:nvPr/>
        </p:nvSpPr>
        <p:spPr>
          <a:xfrm>
            <a:off x="107095" y="5901449"/>
            <a:ext cx="79928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chiborn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and Schulze (2022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2-05731-4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2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8</Words>
  <Application>Microsoft Office PowerPoint</Application>
  <PresentationFormat>On-screen Show (4:3)</PresentationFormat>
  <Paragraphs>10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2</cp:revision>
  <dcterms:created xsi:type="dcterms:W3CDTF">2016-06-15T12:53:43Z</dcterms:created>
  <dcterms:modified xsi:type="dcterms:W3CDTF">2022-06-02T08:16:32Z</dcterms:modified>
</cp:coreProperties>
</file>